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jpeg" ContentType="image/jpeg"/>
  <Override PartName="/ppt/media/image12.png" ContentType="image/png"/>
  <Override PartName="/ppt/media/image7.png" ContentType="image/png"/>
  <Override PartName="/ppt/media/image1.jpeg" ContentType="image/jpeg"/>
  <Override PartName="/ppt/media/image13.png" ContentType="image/png"/>
  <Override PartName="/ppt/media/image11.jpeg" ContentType="image/jpeg"/>
  <Override PartName="/ppt/media/image6.jpeg" ContentType="image/jpeg"/>
  <Override PartName="/ppt/media/image10.png" ContentType="image/png"/>
  <Override PartName="/ppt/media/image5.jpeg" ContentType="image/jpeg"/>
  <Override PartName="/ppt/media/image20.wmf" ContentType="image/x-wmf"/>
  <Override PartName="/ppt/media/image24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wmf" ContentType="image/x-wmf"/>
  <Override PartName="/ppt/media/image18.png" ContentType="image/png"/>
  <Override PartName="/ppt/media/image17.png" ContentType="image/png"/>
  <Override PartName="/ppt/media/image16.jpeg" ContentType="image/jpeg"/>
  <Override PartName="/ppt/media/image14.png" ContentType="image/png"/>
  <Override PartName="/ppt/media/image15.png" ContentType="image/png"/>
  <Override PartName="/ppt/media/image3.jpeg" ContentType="image/jpeg"/>
  <Override PartName="/ppt/media/image4.jpeg" ContentType="image/jpeg"/>
  <Override PartName="/ppt/media/image2.png" ContentType="image/png"/>
  <Override PartName="/ppt/media/image2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A2B11-F789-4765-A4A4-5928B49A67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ED70E-ABA5-4920-8725-64D631819D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CD416-6091-4E3E-BF67-03DE538957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84F20-284A-48E3-8AC9-A5D98E63B8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ABECF-6009-4722-AF63-26C96AEA83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233DE-F717-412B-84F2-3CC7F82D1F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0838A-4498-460F-A05F-52B85DA879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725D4-0C0B-439D-88B6-428500C789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A0B12-B578-455B-B28F-F4D987EB53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B5AA0-12F5-4C66-90BF-38ACA013B2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BB4DD-9FD0-43AB-9236-FB5776EDF5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2CA2F-24B6-4410-AA8D-B4212D9600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B719F9-84AA-49C8-8C6D-DBE156D43D5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jpe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0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25560" y="1500120"/>
          <a:ext cx="2171520" cy="652680"/>
        </p:xfrm>
        <a:graphic>
          <a:graphicData uri="http://schemas.openxmlformats.org/drawingml/2006/table">
            <a:tbl>
              <a:tblPr/>
              <a:tblGrid>
                <a:gridCol w="723960"/>
                <a:gridCol w="361800"/>
                <a:gridCol w="362160"/>
                <a:gridCol w="361800"/>
                <a:gridCol w="361800"/>
              </a:tblGrid>
              <a:tr h="652680"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I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</a:t>
                      </a:r>
                      <a:r>
                        <a:rPr b="0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4"/>
          <p:cNvSpPr/>
          <p:nvPr/>
        </p:nvSpPr>
        <p:spPr>
          <a:xfrm>
            <a:off x="1635120" y="1143000"/>
            <a:ext cx="144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Live T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3276720" y="1500120"/>
          <a:ext cx="2376360" cy="652680"/>
        </p:xfrm>
        <a:graphic>
          <a:graphicData uri="http://schemas.openxmlformats.org/drawingml/2006/table">
            <a:tbl>
              <a:tblPr/>
              <a:tblGrid>
                <a:gridCol w="882360"/>
                <a:gridCol w="412920"/>
                <a:gridCol w="289080"/>
                <a:gridCol w="431640"/>
                <a:gridCol w="360360"/>
              </a:tblGrid>
              <a:tr h="652680"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 (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g/ml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</a:t>
                      </a:r>
                      <a:r>
                        <a:rPr b="0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Box 38"/>
          <p:cNvSpPr/>
          <p:nvPr/>
        </p:nvSpPr>
        <p:spPr>
          <a:xfrm>
            <a:off x="4211640" y="1143000"/>
            <a:ext cx="144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v ES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5975280" y="1500120"/>
          <a:ext cx="2376720" cy="652680"/>
        </p:xfrm>
        <a:graphic>
          <a:graphicData uri="http://schemas.openxmlformats.org/drawingml/2006/table">
            <a:tbl>
              <a:tblPr/>
              <a:tblGrid>
                <a:gridCol w="882720"/>
                <a:gridCol w="412920"/>
                <a:gridCol w="288720"/>
                <a:gridCol w="432000"/>
                <a:gridCol w="360360"/>
              </a:tblGrid>
              <a:tr h="652680"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Con (</a:t>
                      </a:r>
                      <a:r>
                        <a:rPr b="1" lang="el-G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μ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g/m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</a:t>
                      </a: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7640" rIns="17640" tIns="17640" bIns="17640" anchor="ctr">
                      <a:noAutofit/>
                    </a:bodyPr>
                    <a:p>
                      <a:pPr algn="ctr">
                        <a:lnSpc>
                          <a:spcPct val="12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400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7640" marR="17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TextBox 46"/>
          <p:cNvSpPr/>
          <p:nvPr/>
        </p:nvSpPr>
        <p:spPr>
          <a:xfrm>
            <a:off x="6912000" y="1143000"/>
            <a:ext cx="144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v lys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组合 45"/>
          <p:cNvGrpSpPr/>
          <p:nvPr/>
        </p:nvGrpSpPr>
        <p:grpSpPr>
          <a:xfrm>
            <a:off x="222120" y="1862280"/>
            <a:ext cx="8886960" cy="819000"/>
            <a:chOff x="222120" y="1862280"/>
            <a:chExt cx="8886960" cy="819000"/>
          </a:xfrm>
        </p:grpSpPr>
        <p:sp>
          <p:nvSpPr>
            <p:cNvPr id="48" name="TextBox 14"/>
            <p:cNvSpPr/>
            <p:nvPr/>
          </p:nvSpPr>
          <p:spPr>
            <a:xfrm>
              <a:off x="222120" y="1909080"/>
              <a:ext cx="215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Cleaved Caspase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4"/>
            <p:cNvSpPr/>
            <p:nvPr/>
          </p:nvSpPr>
          <p:spPr>
            <a:xfrm>
              <a:off x="956160" y="2356920"/>
              <a:ext cx="216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그룹 51"/>
            <p:cNvGrpSpPr/>
            <p:nvPr/>
          </p:nvGrpSpPr>
          <p:grpSpPr>
            <a:xfrm>
              <a:off x="8485200" y="1862280"/>
              <a:ext cx="623880" cy="819000"/>
              <a:chOff x="8485200" y="1862280"/>
              <a:chExt cx="623880" cy="819000"/>
            </a:xfrm>
          </p:grpSpPr>
          <p:sp>
            <p:nvSpPr>
              <p:cNvPr id="51" name="오른쪽 중괄호 49"/>
              <p:cNvSpPr/>
              <p:nvPr/>
            </p:nvSpPr>
            <p:spPr>
              <a:xfrm>
                <a:off x="8485200" y="1862280"/>
                <a:ext cx="216000" cy="819000"/>
              </a:xfrm>
              <a:custGeom>
                <a:avLst/>
                <a:gdLst>
                  <a:gd name="textAreaLeft" fmla="*/ 0 w 216000"/>
                  <a:gd name="textAreaRight" fmla="*/ 78120 w 216000"/>
                  <a:gd name="textAreaTop" fmla="*/ 5400 h 819000"/>
                  <a:gd name="textAreaBottom" fmla="*/ 813600 h 819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37"/>
                      <a:pt x="10800" y="473"/>
                    </a:cubicBezTo>
                    <a:lnTo>
                      <a:pt x="10800" y="10327"/>
                    </a:lnTo>
                    <a:cubicBezTo>
                      <a:pt x="10800" y="10564"/>
                      <a:pt x="16200" y="10800"/>
                      <a:pt x="21600" y="10800"/>
                    </a:cubicBezTo>
                    <a:cubicBezTo>
                      <a:pt x="16200" y="10800"/>
                      <a:pt x="10800" y="11037"/>
                      <a:pt x="10800" y="11273"/>
                    </a:cubicBezTo>
                    <a:lnTo>
                      <a:pt x="10800" y="21127"/>
                    </a:lnTo>
                    <a:cubicBezTo>
                      <a:pt x="10800" y="21364"/>
                      <a:pt x="54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50"/>
              <p:cNvSpPr/>
              <p:nvPr/>
            </p:nvSpPr>
            <p:spPr>
              <a:xfrm>
                <a:off x="8640360" y="2138400"/>
                <a:ext cx="468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맑은 고딕"/>
                  </a:rPr>
                  <a:t>8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3" name="Picture 62" descr=""/>
            <p:cNvPicPr/>
            <p:nvPr/>
          </p:nvPicPr>
          <p:blipFill>
            <a:blip r:embed="rId1">
              <a:lum bright="-20000"/>
            </a:blip>
            <a:srcRect l="0" t="0" r="0" b="31065"/>
            <a:stretch/>
          </p:blipFill>
          <p:spPr>
            <a:xfrm>
              <a:off x="4211280" y="18748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54" name="Picture 63" descr=""/>
            <p:cNvPicPr/>
            <p:nvPr/>
          </p:nvPicPr>
          <p:blipFill>
            <a:blip r:embed="rId2">
              <a:lum bright="-20000"/>
            </a:blip>
            <a:stretch/>
          </p:blipFill>
          <p:spPr>
            <a:xfrm>
              <a:off x="6912000" y="18748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55" name="Picture 6" descr=""/>
            <p:cNvPicPr/>
            <p:nvPr/>
          </p:nvPicPr>
          <p:blipFill>
            <a:blip r:embed="rId3"/>
            <a:srcRect l="2935" t="19502" r="0" b="18193"/>
            <a:stretch/>
          </p:blipFill>
          <p:spPr>
            <a:xfrm>
              <a:off x="4211280" y="2319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56" name="Picture 7" descr=""/>
            <p:cNvPicPr/>
            <p:nvPr/>
          </p:nvPicPr>
          <p:blipFill>
            <a:blip r:embed="rId4"/>
            <a:srcRect l="1649" t="21965" r="0" b="17206"/>
            <a:stretch/>
          </p:blipFill>
          <p:spPr>
            <a:xfrm>
              <a:off x="1634400" y="2319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57" name="Picture 12" descr=""/>
            <p:cNvPicPr/>
            <p:nvPr/>
          </p:nvPicPr>
          <p:blipFill>
            <a:blip r:embed="rId5"/>
            <a:srcRect l="0" t="17055" r="965" b="16589"/>
            <a:stretch/>
          </p:blipFill>
          <p:spPr>
            <a:xfrm>
              <a:off x="1634400" y="18748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58" name="Picture 57" descr=""/>
            <p:cNvPicPr/>
            <p:nvPr/>
          </p:nvPicPr>
          <p:blipFill>
            <a:blip r:embed="rId6"/>
            <a:srcRect l="5647" t="26270" r="4364" b="25302"/>
            <a:stretch/>
          </p:blipFill>
          <p:spPr>
            <a:xfrm>
              <a:off x="6912000" y="2319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grpSp>
        <p:nvGrpSpPr>
          <p:cNvPr id="59" name="组合 44"/>
          <p:cNvGrpSpPr/>
          <p:nvPr/>
        </p:nvGrpSpPr>
        <p:grpSpPr>
          <a:xfrm>
            <a:off x="222120" y="2892600"/>
            <a:ext cx="8883720" cy="819000"/>
            <a:chOff x="222120" y="2892600"/>
            <a:chExt cx="8883720" cy="819000"/>
          </a:xfrm>
        </p:grpSpPr>
        <p:sp>
          <p:nvSpPr>
            <p:cNvPr id="60" name="TextBox 14"/>
            <p:cNvSpPr/>
            <p:nvPr/>
          </p:nvSpPr>
          <p:spPr>
            <a:xfrm>
              <a:off x="222120" y="2939400"/>
              <a:ext cx="215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Cleaved Caspase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4"/>
            <p:cNvSpPr/>
            <p:nvPr/>
          </p:nvSpPr>
          <p:spPr>
            <a:xfrm>
              <a:off x="956160" y="3385440"/>
              <a:ext cx="216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그룹 52"/>
            <p:cNvGrpSpPr/>
            <p:nvPr/>
          </p:nvGrpSpPr>
          <p:grpSpPr>
            <a:xfrm>
              <a:off x="8483760" y="2892600"/>
              <a:ext cx="622080" cy="819000"/>
              <a:chOff x="8483760" y="2892600"/>
              <a:chExt cx="622080" cy="819000"/>
            </a:xfrm>
          </p:grpSpPr>
          <p:sp>
            <p:nvSpPr>
              <p:cNvPr id="63" name="오른쪽 중괄호 53"/>
              <p:cNvSpPr/>
              <p:nvPr/>
            </p:nvSpPr>
            <p:spPr>
              <a:xfrm>
                <a:off x="8483760" y="2892600"/>
                <a:ext cx="215640" cy="819000"/>
              </a:xfrm>
              <a:custGeom>
                <a:avLst/>
                <a:gdLst>
                  <a:gd name="textAreaLeft" fmla="*/ 0 w 215640"/>
                  <a:gd name="textAreaRight" fmla="*/ 77760 w 215640"/>
                  <a:gd name="textAreaTop" fmla="*/ 5400 h 819000"/>
                  <a:gd name="textAreaBottom" fmla="*/ 813600 h 819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38"/>
                      <a:pt x="10800" y="475"/>
                    </a:cubicBezTo>
                    <a:lnTo>
                      <a:pt x="10800" y="10325"/>
                    </a:lnTo>
                    <a:cubicBezTo>
                      <a:pt x="10800" y="10563"/>
                      <a:pt x="16200" y="10800"/>
                      <a:pt x="21600" y="10800"/>
                    </a:cubicBezTo>
                    <a:cubicBezTo>
                      <a:pt x="16200" y="10800"/>
                      <a:pt x="10800" y="11038"/>
                      <a:pt x="10800" y="11275"/>
                    </a:cubicBezTo>
                    <a:lnTo>
                      <a:pt x="10800" y="21125"/>
                    </a:lnTo>
                    <a:cubicBezTo>
                      <a:pt x="10800" y="21363"/>
                      <a:pt x="54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Box 54"/>
              <p:cNvSpPr/>
              <p:nvPr/>
            </p:nvSpPr>
            <p:spPr>
              <a:xfrm>
                <a:off x="8638560" y="3168720"/>
                <a:ext cx="467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맑은 고딕"/>
                  </a:rPr>
                  <a:t>16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5" name="Picture 66" descr=""/>
            <p:cNvPicPr/>
            <p:nvPr/>
          </p:nvPicPr>
          <p:blipFill>
            <a:blip r:embed="rId7">
              <a:lum bright="-20000"/>
            </a:blip>
            <a:stretch/>
          </p:blipFill>
          <p:spPr>
            <a:xfrm>
              <a:off x="6911640" y="289872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66" name="Picture 4" descr=""/>
            <p:cNvPicPr/>
            <p:nvPr/>
          </p:nvPicPr>
          <p:blipFill>
            <a:blip r:embed="rId8"/>
            <a:srcRect l="3219" t="30096" r="4099" b="22010"/>
            <a:stretch/>
          </p:blipFill>
          <p:spPr>
            <a:xfrm>
              <a:off x="1634400" y="334332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67" name="Picture 9" descr=""/>
            <p:cNvPicPr/>
            <p:nvPr/>
          </p:nvPicPr>
          <p:blipFill>
            <a:blip r:embed="rId9"/>
            <a:srcRect l="1837" t="39530" r="2744" b="31756"/>
            <a:stretch/>
          </p:blipFill>
          <p:spPr>
            <a:xfrm>
              <a:off x="6911640" y="33418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68" name="Picture 13" descr=""/>
            <p:cNvPicPr/>
            <p:nvPr/>
          </p:nvPicPr>
          <p:blipFill>
            <a:blip r:embed="rId10">
              <a:lum bright="-10000"/>
            </a:blip>
            <a:srcRect l="0" t="11726" r="0" b="22997"/>
            <a:stretch/>
          </p:blipFill>
          <p:spPr>
            <a:xfrm>
              <a:off x="1634400" y="289872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69" name="Picture 15" descr=""/>
            <p:cNvPicPr/>
            <p:nvPr/>
          </p:nvPicPr>
          <p:blipFill>
            <a:blip r:embed="rId11"/>
            <a:srcRect l="0" t="4372" r="0" b="14818"/>
            <a:stretch/>
          </p:blipFill>
          <p:spPr>
            <a:xfrm>
              <a:off x="4211280" y="289872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70" name="Picture 58" descr=""/>
            <p:cNvPicPr/>
            <p:nvPr/>
          </p:nvPicPr>
          <p:blipFill>
            <a:blip r:embed="rId12"/>
            <a:srcRect l="5767" t="34213" r="3867" b="34834"/>
            <a:stretch/>
          </p:blipFill>
          <p:spPr>
            <a:xfrm>
              <a:off x="4211280" y="3343320"/>
              <a:ext cx="1440000" cy="3585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grpSp>
        <p:nvGrpSpPr>
          <p:cNvPr id="71" name="组合 43"/>
          <p:cNvGrpSpPr/>
          <p:nvPr/>
        </p:nvGrpSpPr>
        <p:grpSpPr>
          <a:xfrm>
            <a:off x="222120" y="3924360"/>
            <a:ext cx="8883720" cy="819000"/>
            <a:chOff x="222120" y="3924360"/>
            <a:chExt cx="8883720" cy="819000"/>
          </a:xfrm>
        </p:grpSpPr>
        <p:sp>
          <p:nvSpPr>
            <p:cNvPr id="72" name="TextBox 14"/>
            <p:cNvSpPr/>
            <p:nvPr/>
          </p:nvSpPr>
          <p:spPr>
            <a:xfrm>
              <a:off x="222120" y="3969000"/>
              <a:ext cx="215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Cleaved Caspase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14"/>
            <p:cNvSpPr/>
            <p:nvPr/>
          </p:nvSpPr>
          <p:spPr>
            <a:xfrm>
              <a:off x="956160" y="4415040"/>
              <a:ext cx="216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그룹 55"/>
            <p:cNvGrpSpPr/>
            <p:nvPr/>
          </p:nvGrpSpPr>
          <p:grpSpPr>
            <a:xfrm>
              <a:off x="8483760" y="3924360"/>
              <a:ext cx="622080" cy="819000"/>
              <a:chOff x="8483760" y="3924360"/>
              <a:chExt cx="622080" cy="819000"/>
            </a:xfrm>
          </p:grpSpPr>
          <p:sp>
            <p:nvSpPr>
              <p:cNvPr id="75" name="오른쪽 중괄호 56"/>
              <p:cNvSpPr/>
              <p:nvPr/>
            </p:nvSpPr>
            <p:spPr>
              <a:xfrm>
                <a:off x="8483760" y="3924360"/>
                <a:ext cx="215640" cy="819000"/>
              </a:xfrm>
              <a:custGeom>
                <a:avLst/>
                <a:gdLst>
                  <a:gd name="textAreaLeft" fmla="*/ 0 w 215640"/>
                  <a:gd name="textAreaRight" fmla="*/ 77760 w 215640"/>
                  <a:gd name="textAreaTop" fmla="*/ 5400 h 819000"/>
                  <a:gd name="textAreaBottom" fmla="*/ 813600 h 8190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38"/>
                      <a:pt x="10800" y="475"/>
                    </a:cubicBezTo>
                    <a:lnTo>
                      <a:pt x="10800" y="10325"/>
                    </a:lnTo>
                    <a:cubicBezTo>
                      <a:pt x="10800" y="10563"/>
                      <a:pt x="16200" y="10800"/>
                      <a:pt x="21600" y="10800"/>
                    </a:cubicBezTo>
                    <a:cubicBezTo>
                      <a:pt x="16200" y="10800"/>
                      <a:pt x="10800" y="11038"/>
                      <a:pt x="10800" y="11275"/>
                    </a:cubicBezTo>
                    <a:lnTo>
                      <a:pt x="10800" y="21125"/>
                    </a:lnTo>
                    <a:cubicBezTo>
                      <a:pt x="10800" y="21363"/>
                      <a:pt x="54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Box 57"/>
              <p:cNvSpPr/>
              <p:nvPr/>
            </p:nvSpPr>
            <p:spPr>
              <a:xfrm>
                <a:off x="8638560" y="4200480"/>
                <a:ext cx="467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맑은 고딕"/>
                  </a:rPr>
                  <a:t>24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77" name="Picture 69" descr=""/>
            <p:cNvPicPr/>
            <p:nvPr/>
          </p:nvPicPr>
          <p:blipFill>
            <a:blip r:embed="rId13">
              <a:lum bright="-20000"/>
            </a:blip>
            <a:stretch/>
          </p:blipFill>
          <p:spPr>
            <a:xfrm>
              <a:off x="6911640" y="3930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78" name="Picture 8" descr=""/>
            <p:cNvPicPr/>
            <p:nvPr/>
          </p:nvPicPr>
          <p:blipFill>
            <a:blip r:embed="rId14"/>
            <a:srcRect l="1333" t="29945" r="0" b="35982"/>
            <a:stretch/>
          </p:blipFill>
          <p:spPr>
            <a:xfrm>
              <a:off x="1634400" y="437364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79" name="Picture 14" descr=""/>
            <p:cNvPicPr/>
            <p:nvPr/>
          </p:nvPicPr>
          <p:blipFill>
            <a:blip r:embed="rId15"/>
            <a:srcRect l="0" t="14783" r="0" b="0"/>
            <a:stretch/>
          </p:blipFill>
          <p:spPr>
            <a:xfrm>
              <a:off x="1634400" y="3930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80" name="Picture 18" descr=""/>
            <p:cNvPicPr/>
            <p:nvPr/>
          </p:nvPicPr>
          <p:blipFill>
            <a:blip r:embed="rId16"/>
            <a:srcRect l="0" t="12087" r="3218" b="25670"/>
            <a:stretch/>
          </p:blipFill>
          <p:spPr>
            <a:xfrm>
              <a:off x="4214160" y="393048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81" name="Picture 60" descr=""/>
            <p:cNvPicPr/>
            <p:nvPr/>
          </p:nvPicPr>
          <p:blipFill>
            <a:blip r:embed="rId17"/>
            <a:srcRect l="3766" t="21129" r="2048" b="23030"/>
            <a:stretch/>
          </p:blipFill>
          <p:spPr>
            <a:xfrm>
              <a:off x="4214160" y="437364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82" name="Picture 61" descr=""/>
            <p:cNvPicPr/>
            <p:nvPr/>
          </p:nvPicPr>
          <p:blipFill>
            <a:blip r:embed="rId18"/>
            <a:srcRect l="4182" t="33492" r="3860" b="26738"/>
            <a:stretch/>
          </p:blipFill>
          <p:spPr>
            <a:xfrm>
              <a:off x="6911640" y="4373640"/>
              <a:ext cx="1440000" cy="3603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sp>
        <p:nvSpPr>
          <p:cNvPr id="83" name="직사각형 4"/>
          <p:cNvSpPr/>
          <p:nvPr/>
        </p:nvSpPr>
        <p:spPr>
          <a:xfrm>
            <a:off x="344520" y="6137280"/>
            <a:ext cx="1944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. S1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组合 6"/>
          <p:cNvGrpSpPr/>
          <p:nvPr/>
        </p:nvGrpSpPr>
        <p:grpSpPr>
          <a:xfrm>
            <a:off x="2038320" y="549360"/>
            <a:ext cx="5722920" cy="4248000"/>
            <a:chOff x="2038320" y="549360"/>
            <a:chExt cx="5722920" cy="4248000"/>
          </a:xfrm>
        </p:grpSpPr>
        <p:pic>
          <p:nvPicPr>
            <p:cNvPr id="85" name="图片 4" descr="Data 1.emf"/>
            <p:cNvPicPr/>
            <p:nvPr/>
          </p:nvPicPr>
          <p:blipFill>
            <a:blip r:embed="rId1"/>
            <a:stretch/>
          </p:blipFill>
          <p:spPr>
            <a:xfrm>
              <a:off x="2145960" y="549360"/>
              <a:ext cx="5615280" cy="424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TextBox 29"/>
            <p:cNvSpPr/>
            <p:nvPr/>
          </p:nvSpPr>
          <p:spPr>
            <a:xfrm rot="16200000">
              <a:off x="801360" y="2326320"/>
              <a:ext cx="2780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  <a:ea typeface="맑은 고딕"/>
                </a:rPr>
                <a:t>Trichomonas viability (%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직사각형 4"/>
          <p:cNvSpPr/>
          <p:nvPr/>
        </p:nvSpPr>
        <p:spPr>
          <a:xfrm>
            <a:off x="344520" y="6093000"/>
            <a:ext cx="2448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.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그룹 8"/>
          <p:cNvGrpSpPr/>
          <p:nvPr/>
        </p:nvGrpSpPr>
        <p:grpSpPr>
          <a:xfrm>
            <a:off x="2357280" y="571680"/>
            <a:ext cx="4978440" cy="4967280"/>
            <a:chOff x="2357280" y="571680"/>
            <a:chExt cx="4978440" cy="4967280"/>
          </a:xfrm>
        </p:grpSpPr>
        <p:graphicFrame>
          <p:nvGraphicFramePr>
            <p:cNvPr id="89" name="Object 11"/>
            <p:cNvGraphicFramePr/>
            <p:nvPr/>
          </p:nvGraphicFramePr>
          <p:xfrm>
            <a:off x="2692080" y="571680"/>
            <a:ext cx="4643640" cy="496728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90" name="Object 11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692080" y="571680"/>
                      <a:ext cx="4643640" cy="4967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1" name="TextBox 12"/>
            <p:cNvSpPr/>
            <p:nvPr/>
          </p:nvSpPr>
          <p:spPr>
            <a:xfrm>
              <a:off x="4067640" y="2849040"/>
              <a:ext cx="528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12"/>
            <p:cNvSpPr/>
            <p:nvPr/>
          </p:nvSpPr>
          <p:spPr>
            <a:xfrm>
              <a:off x="5048280" y="2810520"/>
              <a:ext cx="528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7"/>
            <p:cNvSpPr/>
            <p:nvPr/>
          </p:nvSpPr>
          <p:spPr>
            <a:xfrm rot="10800000">
              <a:off x="2357280" y="1101960"/>
              <a:ext cx="393480" cy="268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Relative protease  activity (%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직사각형 4"/>
          <p:cNvSpPr/>
          <p:nvPr/>
        </p:nvSpPr>
        <p:spPr>
          <a:xfrm>
            <a:off x="344520" y="6093000"/>
            <a:ext cx="2592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. S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12"/>
          <p:cNvSpPr/>
          <p:nvPr/>
        </p:nvSpPr>
        <p:spPr>
          <a:xfrm>
            <a:off x="6324480" y="2019240"/>
            <a:ext cx="52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직사각형 4"/>
          <p:cNvSpPr/>
          <p:nvPr/>
        </p:nvSpPr>
        <p:spPr>
          <a:xfrm>
            <a:off x="344520" y="6357960"/>
            <a:ext cx="2232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Fig. S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7" name=""/>
          <p:cNvGraphicFramePr/>
          <p:nvPr/>
        </p:nvGraphicFramePr>
        <p:xfrm>
          <a:off x="2143080" y="27000"/>
          <a:ext cx="3273480" cy="914400"/>
        </p:xfrm>
        <a:graphic>
          <a:graphicData uri="http://schemas.openxmlformats.org/drawingml/2006/table">
            <a:tbl>
              <a:tblPr/>
              <a:tblGrid>
                <a:gridCol w="1657440"/>
                <a:gridCol w="403200"/>
                <a:gridCol w="404640"/>
                <a:gridCol w="405000"/>
                <a:gridCol w="403200"/>
              </a:tblGrid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Z-DEVD-FM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0-Phenanthroline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v MOI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98" name="组合 147"/>
          <p:cNvGrpSpPr/>
          <p:nvPr/>
        </p:nvGrpSpPr>
        <p:grpSpPr>
          <a:xfrm>
            <a:off x="2976480" y="6100920"/>
            <a:ext cx="2441520" cy="431640"/>
            <a:chOff x="2976480" y="6100920"/>
            <a:chExt cx="2441520" cy="431640"/>
          </a:xfrm>
        </p:grpSpPr>
        <p:sp>
          <p:nvSpPr>
            <p:cNvPr id="99" name="TextBox 14"/>
            <p:cNvSpPr/>
            <p:nvPr/>
          </p:nvSpPr>
          <p:spPr>
            <a:xfrm>
              <a:off x="2976480" y="6175800"/>
              <a:ext cx="216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α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-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0" name="Picture 27" descr=""/>
            <p:cNvPicPr/>
            <p:nvPr/>
          </p:nvPicPr>
          <p:blipFill>
            <a:blip r:embed="rId1"/>
            <a:srcRect l="2438" t="20419" r="1411" b="24558"/>
            <a:stretch/>
          </p:blipFill>
          <p:spPr>
            <a:xfrm>
              <a:off x="3798360" y="6100920"/>
              <a:ext cx="1619640" cy="431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grpSp>
        <p:nvGrpSpPr>
          <p:cNvPr id="101" name="组合 145"/>
          <p:cNvGrpSpPr/>
          <p:nvPr/>
        </p:nvGrpSpPr>
        <p:grpSpPr>
          <a:xfrm>
            <a:off x="3222720" y="2571840"/>
            <a:ext cx="2852640" cy="1557720"/>
            <a:chOff x="3222720" y="2571840"/>
            <a:chExt cx="2852640" cy="1557720"/>
          </a:xfrm>
        </p:grpSpPr>
        <p:grpSp>
          <p:nvGrpSpPr>
            <p:cNvPr id="102" name="그룹 41"/>
            <p:cNvGrpSpPr/>
            <p:nvPr/>
          </p:nvGrpSpPr>
          <p:grpSpPr>
            <a:xfrm>
              <a:off x="5289120" y="2571840"/>
              <a:ext cx="786240" cy="276480"/>
              <a:chOff x="5289120" y="2571840"/>
              <a:chExt cx="786240" cy="276480"/>
            </a:xfrm>
          </p:grpSpPr>
          <p:sp>
            <p:nvSpPr>
              <p:cNvPr id="103" name="TextBox 30"/>
              <p:cNvSpPr/>
              <p:nvPr/>
            </p:nvSpPr>
            <p:spPr>
              <a:xfrm>
                <a:off x="5289120" y="2571840"/>
                <a:ext cx="78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直接连接符 111"/>
              <p:cNvSpPr/>
              <p:nvPr/>
            </p:nvSpPr>
            <p:spPr>
              <a:xfrm>
                <a:off x="5427720" y="2708280"/>
                <a:ext cx="10764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" name="组合 121"/>
            <p:cNvGrpSpPr/>
            <p:nvPr/>
          </p:nvGrpSpPr>
          <p:grpSpPr>
            <a:xfrm>
              <a:off x="3222720" y="2697120"/>
              <a:ext cx="2843280" cy="1432440"/>
              <a:chOff x="3222720" y="2697120"/>
              <a:chExt cx="2843280" cy="1432440"/>
            </a:xfrm>
          </p:grpSpPr>
          <p:sp>
            <p:nvSpPr>
              <p:cNvPr id="106" name="TextBox 14"/>
              <p:cNvSpPr/>
              <p:nvPr/>
            </p:nvSpPr>
            <p:spPr>
              <a:xfrm>
                <a:off x="3222720" y="3197160"/>
                <a:ext cx="1208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맑은 고딕"/>
                  </a:rPr>
                  <a:t>Mcl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07" name="Picture 4" descr=""/>
              <p:cNvPicPr/>
              <p:nvPr/>
            </p:nvPicPr>
            <p:blipFill>
              <a:blip r:embed="rId2"/>
              <a:srcRect l="4106" t="0" r="3943" b="7069"/>
              <a:stretch/>
            </p:blipFill>
            <p:spPr>
              <a:xfrm>
                <a:off x="3798720" y="2697120"/>
                <a:ext cx="1620360" cy="138708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grpSp>
            <p:nvGrpSpPr>
              <p:cNvPr id="108" name="组合 45"/>
              <p:cNvGrpSpPr/>
              <p:nvPr/>
            </p:nvGrpSpPr>
            <p:grpSpPr>
              <a:xfrm>
                <a:off x="5279760" y="2950560"/>
                <a:ext cx="786240" cy="276480"/>
                <a:chOff x="5279760" y="2950560"/>
                <a:chExt cx="786240" cy="276480"/>
              </a:xfrm>
            </p:grpSpPr>
            <p:sp>
              <p:nvSpPr>
                <p:cNvPr id="109" name="TextBox 31"/>
                <p:cNvSpPr/>
                <p:nvPr/>
              </p:nvSpPr>
              <p:spPr>
                <a:xfrm>
                  <a:off x="5279760" y="2950560"/>
                  <a:ext cx="786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直接连接符 114"/>
                <p:cNvSpPr/>
                <p:nvPr/>
              </p:nvSpPr>
              <p:spPr>
                <a:xfrm>
                  <a:off x="5427720" y="3078000"/>
                  <a:ext cx="10764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1" name="组合 46"/>
              <p:cNvGrpSpPr/>
              <p:nvPr/>
            </p:nvGrpSpPr>
            <p:grpSpPr>
              <a:xfrm>
                <a:off x="5279760" y="3252960"/>
                <a:ext cx="786240" cy="276480"/>
                <a:chOff x="5279760" y="3252960"/>
                <a:chExt cx="786240" cy="276480"/>
              </a:xfrm>
            </p:grpSpPr>
            <p:sp>
              <p:nvSpPr>
                <p:cNvPr id="112" name="TextBox 31"/>
                <p:cNvSpPr/>
                <p:nvPr/>
              </p:nvSpPr>
              <p:spPr>
                <a:xfrm>
                  <a:off x="5279760" y="3252960"/>
                  <a:ext cx="786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直接连接符 117"/>
                <p:cNvSpPr/>
                <p:nvPr/>
              </p:nvSpPr>
              <p:spPr>
                <a:xfrm>
                  <a:off x="5427720" y="3379320"/>
                  <a:ext cx="10764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4" name="组合 50"/>
              <p:cNvGrpSpPr/>
              <p:nvPr/>
            </p:nvGrpSpPr>
            <p:grpSpPr>
              <a:xfrm>
                <a:off x="5276520" y="3853080"/>
                <a:ext cx="786240" cy="276480"/>
                <a:chOff x="5276520" y="3853080"/>
                <a:chExt cx="786240" cy="276480"/>
              </a:xfrm>
            </p:grpSpPr>
            <p:sp>
              <p:nvSpPr>
                <p:cNvPr id="115" name="TextBox 31"/>
                <p:cNvSpPr/>
                <p:nvPr/>
              </p:nvSpPr>
              <p:spPr>
                <a:xfrm>
                  <a:off x="5276520" y="3853080"/>
                  <a:ext cx="786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直接连接符 120"/>
                <p:cNvSpPr/>
                <p:nvPr/>
              </p:nvSpPr>
              <p:spPr>
                <a:xfrm>
                  <a:off x="5424480" y="4008600"/>
                  <a:ext cx="10764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17" name="TextBox 14"/>
          <p:cNvSpPr/>
          <p:nvPr/>
        </p:nvSpPr>
        <p:spPr>
          <a:xfrm>
            <a:off x="3149640" y="4675320"/>
            <a:ext cx="216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Bcl-x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Picture 8" descr=""/>
          <p:cNvPicPr/>
          <p:nvPr/>
        </p:nvPicPr>
        <p:blipFill>
          <a:blip r:embed="rId3"/>
          <a:srcRect l="8341" t="0" r="11216" b="0"/>
          <a:stretch/>
        </p:blipFill>
        <p:spPr>
          <a:xfrm>
            <a:off x="3798720" y="4183200"/>
            <a:ext cx="1619280" cy="13064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grpSp>
        <p:nvGrpSpPr>
          <p:cNvPr id="119" name="组合 54"/>
          <p:cNvGrpSpPr/>
          <p:nvPr/>
        </p:nvGrpSpPr>
        <p:grpSpPr>
          <a:xfrm>
            <a:off x="5267160" y="4307040"/>
            <a:ext cx="785880" cy="276480"/>
            <a:chOff x="5267160" y="4307040"/>
            <a:chExt cx="785880" cy="276480"/>
          </a:xfrm>
        </p:grpSpPr>
        <p:sp>
          <p:nvSpPr>
            <p:cNvPr id="120" name="TextBox 31"/>
            <p:cNvSpPr/>
            <p:nvPr/>
          </p:nvSpPr>
          <p:spPr>
            <a:xfrm>
              <a:off x="5267160" y="4307040"/>
              <a:ext cx="78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直接连接符 137"/>
            <p:cNvSpPr/>
            <p:nvPr/>
          </p:nvSpPr>
          <p:spPr>
            <a:xfrm>
              <a:off x="5414760" y="4434120"/>
              <a:ext cx="1080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组合 57"/>
          <p:cNvGrpSpPr/>
          <p:nvPr/>
        </p:nvGrpSpPr>
        <p:grpSpPr>
          <a:xfrm>
            <a:off x="5267160" y="4651200"/>
            <a:ext cx="785880" cy="276480"/>
            <a:chOff x="5267160" y="4651200"/>
            <a:chExt cx="785880" cy="276480"/>
          </a:xfrm>
        </p:grpSpPr>
        <p:sp>
          <p:nvSpPr>
            <p:cNvPr id="123" name="TextBox 31"/>
            <p:cNvSpPr/>
            <p:nvPr/>
          </p:nvSpPr>
          <p:spPr>
            <a:xfrm>
              <a:off x="5267160" y="4651200"/>
              <a:ext cx="78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直接连接符 135"/>
            <p:cNvSpPr/>
            <p:nvPr/>
          </p:nvSpPr>
          <p:spPr>
            <a:xfrm>
              <a:off x="5414760" y="4798800"/>
              <a:ext cx="1080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组合 60"/>
          <p:cNvGrpSpPr/>
          <p:nvPr/>
        </p:nvGrpSpPr>
        <p:grpSpPr>
          <a:xfrm>
            <a:off x="5273640" y="4991040"/>
            <a:ext cx="787320" cy="276480"/>
            <a:chOff x="5273640" y="4991040"/>
            <a:chExt cx="787320" cy="276480"/>
          </a:xfrm>
        </p:grpSpPr>
        <p:sp>
          <p:nvSpPr>
            <p:cNvPr id="126" name="TextBox 31"/>
            <p:cNvSpPr/>
            <p:nvPr/>
          </p:nvSpPr>
          <p:spPr>
            <a:xfrm>
              <a:off x="5273640" y="4991040"/>
              <a:ext cx="78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直接连接符 133"/>
            <p:cNvSpPr/>
            <p:nvPr/>
          </p:nvSpPr>
          <p:spPr>
            <a:xfrm>
              <a:off x="5421240" y="5137200"/>
              <a:ext cx="10764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" name="组合 142"/>
          <p:cNvGrpSpPr/>
          <p:nvPr/>
        </p:nvGrpSpPr>
        <p:grpSpPr>
          <a:xfrm>
            <a:off x="3127320" y="5572080"/>
            <a:ext cx="2290680" cy="432000"/>
            <a:chOff x="3127320" y="5572080"/>
            <a:chExt cx="2290680" cy="432000"/>
          </a:xfrm>
        </p:grpSpPr>
        <p:sp>
          <p:nvSpPr>
            <p:cNvPr id="129" name="TextBox 14"/>
            <p:cNvSpPr/>
            <p:nvPr/>
          </p:nvSpPr>
          <p:spPr>
            <a:xfrm>
              <a:off x="3127320" y="5643720"/>
              <a:ext cx="2161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BimE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0" name="Picture 11" descr=""/>
            <p:cNvPicPr/>
            <p:nvPr/>
          </p:nvPicPr>
          <p:blipFill>
            <a:blip r:embed="rId4"/>
            <a:srcRect l="4178" t="19465" r="9601" b="22092"/>
            <a:stretch/>
          </p:blipFill>
          <p:spPr>
            <a:xfrm>
              <a:off x="3798720" y="5572080"/>
              <a:ext cx="1619280" cy="43200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</p:grpSp>
      <p:grpSp>
        <p:nvGrpSpPr>
          <p:cNvPr id="131" name="组合 146"/>
          <p:cNvGrpSpPr/>
          <p:nvPr/>
        </p:nvGrpSpPr>
        <p:grpSpPr>
          <a:xfrm>
            <a:off x="3192480" y="642960"/>
            <a:ext cx="2892240" cy="1962720"/>
            <a:chOff x="3192480" y="642960"/>
            <a:chExt cx="2892240" cy="1962720"/>
          </a:xfrm>
        </p:grpSpPr>
        <p:sp>
          <p:nvSpPr>
            <p:cNvPr id="132" name="TextBox 14"/>
            <p:cNvSpPr/>
            <p:nvPr/>
          </p:nvSpPr>
          <p:spPr>
            <a:xfrm>
              <a:off x="3192480" y="161136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맑은 고딕"/>
                </a:rPr>
                <a:t>PAR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3" name="Picture 2" descr=""/>
            <p:cNvPicPr/>
            <p:nvPr/>
          </p:nvPicPr>
          <p:blipFill>
            <a:blip r:embed="rId5"/>
            <a:srcRect l="11229" t="3957" r="3774" b="10920"/>
            <a:stretch/>
          </p:blipFill>
          <p:spPr>
            <a:xfrm>
              <a:off x="3798360" y="955800"/>
              <a:ext cx="1619640" cy="16430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grpSp>
          <p:nvGrpSpPr>
            <p:cNvPr id="134" name="组合 144"/>
            <p:cNvGrpSpPr/>
            <p:nvPr/>
          </p:nvGrpSpPr>
          <p:grpSpPr>
            <a:xfrm>
              <a:off x="5272200" y="642960"/>
              <a:ext cx="812520" cy="1962720"/>
              <a:chOff x="5272200" y="642960"/>
              <a:chExt cx="812520" cy="1962720"/>
            </a:xfrm>
          </p:grpSpPr>
          <p:grpSp>
            <p:nvGrpSpPr>
              <p:cNvPr id="135" name="组合 54"/>
              <p:cNvGrpSpPr/>
              <p:nvPr/>
            </p:nvGrpSpPr>
            <p:grpSpPr>
              <a:xfrm>
                <a:off x="5300640" y="859320"/>
                <a:ext cx="784080" cy="276480"/>
                <a:chOff x="5300640" y="859320"/>
                <a:chExt cx="784080" cy="276480"/>
              </a:xfrm>
            </p:grpSpPr>
            <p:sp>
              <p:nvSpPr>
                <p:cNvPr id="136" name="TextBox 31"/>
                <p:cNvSpPr/>
                <p:nvPr/>
              </p:nvSpPr>
              <p:spPr>
                <a:xfrm>
                  <a:off x="5300640" y="859320"/>
                  <a:ext cx="78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3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直接连接符 91"/>
                <p:cNvSpPr/>
                <p:nvPr/>
              </p:nvSpPr>
              <p:spPr>
                <a:xfrm>
                  <a:off x="5429160" y="1002960"/>
                  <a:ext cx="1062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8" name="组合 57"/>
              <p:cNvGrpSpPr/>
              <p:nvPr/>
            </p:nvGrpSpPr>
            <p:grpSpPr>
              <a:xfrm>
                <a:off x="5300640" y="1079640"/>
                <a:ext cx="784080" cy="276480"/>
                <a:chOff x="5300640" y="1079640"/>
                <a:chExt cx="784080" cy="276480"/>
              </a:xfrm>
            </p:grpSpPr>
            <p:sp>
              <p:nvSpPr>
                <p:cNvPr id="139" name="TextBox 31"/>
                <p:cNvSpPr/>
                <p:nvPr/>
              </p:nvSpPr>
              <p:spPr>
                <a:xfrm>
                  <a:off x="5300640" y="1079640"/>
                  <a:ext cx="78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直接连接符 89"/>
                <p:cNvSpPr/>
                <p:nvPr/>
              </p:nvSpPr>
              <p:spPr>
                <a:xfrm>
                  <a:off x="5429160" y="1236600"/>
                  <a:ext cx="1062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1" name="组合 60"/>
              <p:cNvGrpSpPr/>
              <p:nvPr/>
            </p:nvGrpSpPr>
            <p:grpSpPr>
              <a:xfrm>
                <a:off x="5276880" y="1704240"/>
                <a:ext cx="784080" cy="276480"/>
                <a:chOff x="5276880" y="1704240"/>
                <a:chExt cx="784080" cy="276480"/>
              </a:xfrm>
            </p:grpSpPr>
            <p:sp>
              <p:nvSpPr>
                <p:cNvPr id="142" name="TextBox 31"/>
                <p:cNvSpPr/>
                <p:nvPr/>
              </p:nvSpPr>
              <p:spPr>
                <a:xfrm>
                  <a:off x="5276880" y="1704240"/>
                  <a:ext cx="78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5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直接连接符 87"/>
                <p:cNvSpPr/>
                <p:nvPr/>
              </p:nvSpPr>
              <p:spPr>
                <a:xfrm>
                  <a:off x="5424480" y="1862280"/>
                  <a:ext cx="10764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4" name="组合 57"/>
              <p:cNvGrpSpPr/>
              <p:nvPr/>
            </p:nvGrpSpPr>
            <p:grpSpPr>
              <a:xfrm>
                <a:off x="5272200" y="1398960"/>
                <a:ext cx="784080" cy="276480"/>
                <a:chOff x="5272200" y="1398960"/>
                <a:chExt cx="784080" cy="276480"/>
              </a:xfrm>
            </p:grpSpPr>
            <p:sp>
              <p:nvSpPr>
                <p:cNvPr id="145" name="TextBox 31"/>
                <p:cNvSpPr/>
                <p:nvPr/>
              </p:nvSpPr>
              <p:spPr>
                <a:xfrm>
                  <a:off x="5272200" y="1398960"/>
                  <a:ext cx="78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7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直接连接符 85"/>
                <p:cNvSpPr/>
                <p:nvPr/>
              </p:nvSpPr>
              <p:spPr>
                <a:xfrm>
                  <a:off x="5421240" y="1530360"/>
                  <a:ext cx="10620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7" name="组合 60"/>
              <p:cNvGrpSpPr/>
              <p:nvPr/>
            </p:nvGrpSpPr>
            <p:grpSpPr>
              <a:xfrm>
                <a:off x="5276880" y="2329200"/>
                <a:ext cx="784080" cy="276480"/>
                <a:chOff x="5276880" y="2329200"/>
                <a:chExt cx="784080" cy="276480"/>
              </a:xfrm>
            </p:grpSpPr>
            <p:sp>
              <p:nvSpPr>
                <p:cNvPr id="148" name="TextBox 31"/>
                <p:cNvSpPr/>
                <p:nvPr/>
              </p:nvSpPr>
              <p:spPr>
                <a:xfrm>
                  <a:off x="5276880" y="2329200"/>
                  <a:ext cx="784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直接连接符 83"/>
                <p:cNvSpPr/>
                <p:nvPr/>
              </p:nvSpPr>
              <p:spPr>
                <a:xfrm>
                  <a:off x="5424480" y="2479680"/>
                  <a:ext cx="10764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0" name="TextBox 35"/>
              <p:cNvSpPr/>
              <p:nvPr/>
            </p:nvSpPr>
            <p:spPr>
              <a:xfrm>
                <a:off x="5299200" y="642960"/>
                <a:ext cx="784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MW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1" name="组合 60"/>
          <p:cNvGrpSpPr/>
          <p:nvPr/>
        </p:nvGrpSpPr>
        <p:grpSpPr>
          <a:xfrm>
            <a:off x="5286240" y="5638680"/>
            <a:ext cx="785880" cy="276480"/>
            <a:chOff x="5286240" y="5638680"/>
            <a:chExt cx="785880" cy="276480"/>
          </a:xfrm>
        </p:grpSpPr>
        <p:sp>
          <p:nvSpPr>
            <p:cNvPr id="152" name="TextBox 31"/>
            <p:cNvSpPr/>
            <p:nvPr/>
          </p:nvSpPr>
          <p:spPr>
            <a:xfrm>
              <a:off x="5286240" y="5638680"/>
              <a:ext cx="78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直接连接符 59"/>
            <p:cNvSpPr/>
            <p:nvPr/>
          </p:nvSpPr>
          <p:spPr>
            <a:xfrm>
              <a:off x="5433840" y="5784840"/>
              <a:ext cx="1080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4" name="组合 60"/>
          <p:cNvGrpSpPr/>
          <p:nvPr/>
        </p:nvGrpSpPr>
        <p:grpSpPr>
          <a:xfrm>
            <a:off x="5286240" y="6172200"/>
            <a:ext cx="785880" cy="276480"/>
            <a:chOff x="5286240" y="6172200"/>
            <a:chExt cx="785880" cy="276480"/>
          </a:xfrm>
        </p:grpSpPr>
        <p:sp>
          <p:nvSpPr>
            <p:cNvPr id="155" name="TextBox 31"/>
            <p:cNvSpPr/>
            <p:nvPr/>
          </p:nvSpPr>
          <p:spPr>
            <a:xfrm>
              <a:off x="5286240" y="6172200"/>
              <a:ext cx="78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直接连接符 62"/>
            <p:cNvSpPr/>
            <p:nvPr/>
          </p:nvSpPr>
          <p:spPr>
            <a:xfrm>
              <a:off x="5433840" y="6318360"/>
              <a:ext cx="10800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19T00:53:55Z</dcterms:created>
  <dc:creator>微软用户</dc:creator>
  <dc:description/>
  <dc:language>en-US</dc:language>
  <cp:lastModifiedBy>이영하</cp:lastModifiedBy>
  <dcterms:modified xsi:type="dcterms:W3CDTF">2014-10-04T14:07:18Z</dcterms:modified>
  <cp:revision>22</cp:revision>
  <dc:subject/>
  <dc:title>幻灯片 1</dc:title>
</cp:coreProperties>
</file>